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106738" cy="51228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F3E2D-D962-4932-80BE-3F40B878A0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31840" y="1479240"/>
            <a:ext cx="264456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31840" y="3084120"/>
            <a:ext cx="264456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A2C7E-F9BC-42AB-B8A6-748C735264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31840" y="147924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586880" y="147924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31840" y="308412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586880" y="308412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F166C-9CE5-4833-A6AD-7915DB94EE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31840" y="1479240"/>
            <a:ext cx="85140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126080" y="1479240"/>
            <a:ext cx="85140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020680" y="1479240"/>
            <a:ext cx="85140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31840" y="3084120"/>
            <a:ext cx="85140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126080" y="3084120"/>
            <a:ext cx="85140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020680" y="3084120"/>
            <a:ext cx="85140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7BF6C8-DBB5-44E8-9673-0513E639A5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31840" y="1479240"/>
            <a:ext cx="2644560" cy="3071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76"/>
              </a:spcBef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95BC86-5C96-4554-AF0A-5F1C3C82D0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31840" y="1479240"/>
            <a:ext cx="2644560" cy="30718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75692-D128-44FC-A4A2-34AC8402B4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31840" y="1479240"/>
            <a:ext cx="1290240" cy="30718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586880" y="1479240"/>
            <a:ext cx="1290240" cy="30718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15462E-EB37-4812-8CBB-096182B2B8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43CEB-0A5C-4D3A-861F-D0A0B8FD54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31840" y="455760"/>
            <a:ext cx="2644560" cy="3952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76"/>
              </a:spcBef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7C6CF-BC4B-4C2B-BDED-AA7D7ACCF6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31840" y="147924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586880" y="1479240"/>
            <a:ext cx="1290240" cy="30718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31840" y="308412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43778A-5AB1-48B8-82EF-5718F30FD4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31840" y="1479240"/>
            <a:ext cx="1290240" cy="30718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586880" y="147924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586880" y="308412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F8CE57-8BD1-45DE-8917-CBCE899E9B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31840" y="147924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586880" y="1479240"/>
            <a:ext cx="129024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31840" y="3084120"/>
            <a:ext cx="2644560" cy="146520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601002-E5F2-4857-B530-015EEF9DB4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31840" y="455760"/>
            <a:ext cx="2644560" cy="8524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2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31840" y="1479240"/>
            <a:ext cx="2644560" cy="30718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rmAutofit fontScale="85000"/>
          </a:bodyPr>
          <a:p>
            <a:pPr marL="169920" indent="-169920">
              <a:spcBef>
                <a:spcPts val="476"/>
              </a:spcBef>
              <a:buClr>
                <a:srgbClr val="000000"/>
              </a:buClr>
              <a:buFont typeface="Times"/>
              <a:buChar char="•"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1" marL="366840" indent="-141480">
              <a:spcBef>
                <a:spcPts val="476"/>
              </a:spcBef>
              <a:buClr>
                <a:srgbClr val="000000"/>
              </a:buClr>
              <a:buFont typeface="Times"/>
              <a:buChar char="–"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2" marL="563760" indent="-111960">
              <a:spcBef>
                <a:spcPts val="476"/>
              </a:spcBef>
              <a:buClr>
                <a:srgbClr val="000000"/>
              </a:buClr>
              <a:buFont typeface="Times"/>
              <a:buChar char="•"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3" marL="790560" indent="-113040">
              <a:spcBef>
                <a:spcPts val="476"/>
              </a:spcBef>
              <a:buClr>
                <a:srgbClr val="000000"/>
              </a:buClr>
              <a:buFont typeface="Times"/>
              <a:buChar char="–"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4" marL="1015920" indent="-113400">
              <a:spcBef>
                <a:spcPts val="476"/>
              </a:spcBef>
              <a:buClr>
                <a:srgbClr val="000000"/>
              </a:buClr>
              <a:buFont typeface="Times"/>
              <a:buChar char="»"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5" marL="1015920" indent="-113400">
              <a:spcBef>
                <a:spcPts val="476"/>
              </a:spcBef>
              <a:buClr>
                <a:srgbClr val="000000"/>
              </a:buClr>
              <a:buFont typeface="Times"/>
              <a:buChar char="»"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6" marL="1015920" indent="-113400">
              <a:spcBef>
                <a:spcPts val="476"/>
              </a:spcBef>
              <a:buClr>
                <a:srgbClr val="000000"/>
              </a:buClr>
              <a:buFont typeface="Times"/>
              <a:buChar char="»"/>
              <a:tabLst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31480" y="4665600"/>
            <a:ext cx="647640" cy="3412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Autofit/>
          </a:bodyPr>
          <a:lstStyle>
            <a:lvl1pPr indent="0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  <a:defRPr b="0" lang="en-US" sz="8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062000" y="4665600"/>
            <a:ext cx="984240" cy="3412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Autofit/>
          </a:bodyPr>
          <a:lstStyle>
            <a:lvl1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  <a:defRPr b="0" lang="en-US" sz="8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228400" y="4665600"/>
            <a:ext cx="647640" cy="341280"/>
          </a:xfrm>
          <a:prstGeom prst="rect">
            <a:avLst/>
          </a:prstGeom>
          <a:noFill/>
          <a:ln w="0">
            <a:noFill/>
          </a:ln>
        </p:spPr>
        <p:txBody>
          <a:bodyPr lIns="53280" rIns="53280" tIns="26640" bIns="26640" anchor="t">
            <a:noAutofit/>
          </a:bodyPr>
          <a:lstStyle>
            <a:lvl1pPr indent="0" algn="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  <a:defRPr b="0" lang="en-US" sz="8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531720"/>
                <a:tab algn="l" pos="1063800"/>
                <a:tab algn="l" pos="1595520"/>
                <a:tab algn="l" pos="2127240"/>
                <a:tab algn="l" pos="2658960"/>
                <a:tab algn="l" pos="3191040"/>
                <a:tab algn="l" pos="3722760"/>
                <a:tab algn="l" pos="4254480"/>
                <a:tab algn="l" pos="4786200"/>
                <a:tab algn="l" pos="5318280"/>
                <a:tab algn="l" pos="5850000"/>
                <a:tab algn="l" pos="6381720"/>
                <a:tab algn="l" pos="6913440"/>
                <a:tab algn="l" pos="7445520"/>
                <a:tab algn="l" pos="7977240"/>
                <a:tab algn="l" pos="8508960"/>
                <a:tab algn="l" pos="9040680"/>
                <a:tab algn="l" pos="9572760"/>
                <a:tab algn="l" pos="10104480"/>
                <a:tab algn="l" pos="10636200"/>
              </a:tabLst>
            </a:pPr>
            <a:fld id="{C9CEC953-F288-4AF8-8075-AC6D2B147995}" type="slidenum"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84240" y="198360"/>
            <a:ext cx="3576240" cy="4771800"/>
            <a:chOff x="-84240" y="198360"/>
            <a:chExt cx="3576240" cy="4771800"/>
          </a:xfrm>
        </p:grpSpPr>
        <p:sp>
          <p:nvSpPr>
            <p:cNvPr id="42" name=""/>
            <p:cNvSpPr/>
            <p:nvPr/>
          </p:nvSpPr>
          <p:spPr>
            <a:xfrm>
              <a:off x="146880" y="198360"/>
              <a:ext cx="36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.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-84240" y="244080"/>
              <a:ext cx="3076920" cy="2167920"/>
              <a:chOff x="-84240" y="244080"/>
              <a:chExt cx="3076920" cy="2167920"/>
            </a:xfrm>
          </p:grpSpPr>
          <p:pic>
            <p:nvPicPr>
              <p:cNvPr id="44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082520" y="1040760"/>
                <a:ext cx="1651320" cy="609120"/>
              </a:xfrm>
              <a:prstGeom prst="rect">
                <a:avLst/>
              </a:prstGeom>
              <a:ln w="3240">
                <a:solidFill>
                  <a:srgbClr val="969696"/>
                </a:solidFill>
                <a:miter/>
              </a:ln>
            </p:spPr>
          </p:pic>
          <p:pic>
            <p:nvPicPr>
              <p:cNvPr id="45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1082520" y="1726560"/>
                <a:ext cx="1625760" cy="685440"/>
              </a:xfrm>
              <a:prstGeom prst="rect">
                <a:avLst/>
              </a:prstGeom>
              <a:ln w="9360">
                <a:solidFill>
                  <a:srgbClr val="808080"/>
                </a:solidFill>
                <a:miter/>
              </a:ln>
            </p:spPr>
          </p:pic>
          <p:sp>
            <p:nvSpPr>
              <p:cNvPr id="46" name=""/>
              <p:cNvSpPr/>
              <p:nvPr/>
            </p:nvSpPr>
            <p:spPr>
              <a:xfrm>
                <a:off x="-84240" y="821520"/>
                <a:ext cx="304812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RNAseH/Oligo (dT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) -   +           -       + 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113840" y="502560"/>
                <a:ext cx="63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Input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028600" y="502560"/>
                <a:ext cx="729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Eluted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177920" y="735840"/>
                <a:ext cx="525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1987560" y="735840"/>
                <a:ext cx="63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074600" y="244080"/>
                <a:ext cx="1918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Oligo(dT) Sepharos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106640" y="469440"/>
                <a:ext cx="1749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86280" y="1296360"/>
                <a:ext cx="54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HO-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873000" y="1440720"/>
                <a:ext cx="10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45520" y="1841040"/>
                <a:ext cx="9122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Ethidium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Bromid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001880" y="1796400"/>
                <a:ext cx="54000" cy="501480"/>
              </a:xfrm>
              <a:custGeom>
                <a:avLst/>
                <a:gdLst>
                  <a:gd name="textAreaLeft" fmla="*/ 34560 w 54000"/>
                  <a:gd name="textAreaRight" fmla="*/ 54360 w 54000"/>
                  <a:gd name="textAreaTop" fmla="*/ 12960 h 501480"/>
                  <a:gd name="textAreaBottom" fmla="*/ 488520 h 5014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900"/>
                      <a:pt x="10800" y="1800"/>
                    </a:cubicBezTo>
                    <a:lnTo>
                      <a:pt x="10800" y="9000"/>
                    </a:lnTo>
                    <a:cubicBezTo>
                      <a:pt x="10800" y="9900"/>
                      <a:pt x="5400" y="10800"/>
                      <a:pt x="0" y="10800"/>
                    </a:cubicBezTo>
                    <a:cubicBezTo>
                      <a:pt x="5400" y="10800"/>
                      <a:pt x="10800" y="11700"/>
                      <a:pt x="10800" y="12600"/>
                    </a:cubicBezTo>
                    <a:lnTo>
                      <a:pt x="10800" y="19800"/>
                    </a:lnTo>
                    <a:cubicBezTo>
                      <a:pt x="10800" y="20700"/>
                      <a:pt x="16200" y="21600"/>
                      <a:pt x="21600" y="21600"/>
                    </a:cubicBezTo>
                  </a:path>
                </a:pathLst>
              </a:cu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57" name=""/>
            <p:cNvSpPr/>
            <p:nvPr/>
          </p:nvSpPr>
          <p:spPr>
            <a:xfrm>
              <a:off x="146880" y="2636640"/>
              <a:ext cx="36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.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8" name=""/>
            <p:cNvGrpSpPr/>
            <p:nvPr/>
          </p:nvGrpSpPr>
          <p:grpSpPr>
            <a:xfrm>
              <a:off x="7200" y="2784240"/>
              <a:ext cx="3484800" cy="2185920"/>
              <a:chOff x="7200" y="2784240"/>
              <a:chExt cx="3484800" cy="2185920"/>
            </a:xfrm>
          </p:grpSpPr>
          <p:pic>
            <p:nvPicPr>
              <p:cNvPr id="59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888480" y="3217320"/>
                <a:ext cx="1955880" cy="533520"/>
              </a:xfrm>
              <a:prstGeom prst="rect">
                <a:avLst/>
              </a:prstGeom>
              <a:ln w="3240">
                <a:solidFill>
                  <a:srgbClr val="969696"/>
                </a:solidFill>
                <a:miter/>
              </a:ln>
            </p:spPr>
          </p:pic>
          <p:sp>
            <p:nvSpPr>
              <p:cNvPr id="60" name=""/>
              <p:cNvSpPr/>
              <p:nvPr/>
            </p:nvSpPr>
            <p:spPr>
              <a:xfrm>
                <a:off x="7200" y="3026880"/>
                <a:ext cx="1018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Time AD (h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987120" y="2787120"/>
                <a:ext cx="820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786320" y="2784240"/>
                <a:ext cx="1095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permineNO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945720" y="2987280"/>
                <a:ext cx="8175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V="1">
                <a:off x="1846080" y="2987280"/>
                <a:ext cx="768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65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888480" y="3846240"/>
                <a:ext cx="1967040" cy="495000"/>
              </a:xfrm>
              <a:prstGeom prst="rect">
                <a:avLst/>
              </a:prstGeom>
              <a:ln w="3240">
                <a:solidFill>
                  <a:srgbClr val="969696"/>
                </a:solidFill>
                <a:miter/>
              </a:ln>
            </p:spPr>
          </p:pic>
          <p:pic>
            <p:nvPicPr>
              <p:cNvPr id="66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888480" y="4493880"/>
                <a:ext cx="1967040" cy="457200"/>
              </a:xfrm>
              <a:prstGeom prst="rect">
                <a:avLst/>
              </a:prstGeom>
              <a:ln w="3240">
                <a:solidFill>
                  <a:srgbClr val="4d4d4d"/>
                </a:solidFill>
                <a:miter/>
              </a:ln>
            </p:spPr>
          </p:pic>
          <p:sp>
            <p:nvSpPr>
              <p:cNvPr id="67" name=""/>
              <p:cNvSpPr/>
              <p:nvPr/>
            </p:nvSpPr>
            <p:spPr>
              <a:xfrm>
                <a:off x="297000" y="3377880"/>
                <a:ext cx="54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HO-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732960" y="3503160"/>
                <a:ext cx="104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111600" y="3978000"/>
                <a:ext cx="63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GAPDH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748800" y="4112640"/>
                <a:ext cx="10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39480" y="3028680"/>
                <a:ext cx="3152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 1  2  4  8 12  0  1 2  4 8 12 input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75240" y="4511160"/>
                <a:ext cx="9122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Ethidium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Bromide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823680" y="4619160"/>
                <a:ext cx="54000" cy="349200"/>
              </a:xfrm>
              <a:custGeom>
                <a:avLst/>
                <a:gdLst>
                  <a:gd name="textAreaLeft" fmla="*/ 34560 w 54000"/>
                  <a:gd name="textAreaRight" fmla="*/ 54360 w 54000"/>
                  <a:gd name="textAreaTop" fmla="*/ 9000 h 349200"/>
                  <a:gd name="textAreaBottom" fmla="*/ 340200 h 3492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900"/>
                      <a:pt x="10800" y="1800"/>
                    </a:cubicBezTo>
                    <a:lnTo>
                      <a:pt x="10800" y="9000"/>
                    </a:lnTo>
                    <a:cubicBezTo>
                      <a:pt x="10800" y="9900"/>
                      <a:pt x="5400" y="10800"/>
                      <a:pt x="0" y="10800"/>
                    </a:cubicBezTo>
                    <a:cubicBezTo>
                      <a:pt x="5400" y="10800"/>
                      <a:pt x="10800" y="11700"/>
                      <a:pt x="10800" y="12600"/>
                    </a:cubicBezTo>
                    <a:lnTo>
                      <a:pt x="10800" y="19800"/>
                    </a:lnTo>
                    <a:cubicBezTo>
                      <a:pt x="10800" y="20700"/>
                      <a:pt x="16200" y="21600"/>
                      <a:pt x="21600" y="21600"/>
                    </a:cubicBezTo>
                  </a:path>
                </a:pathLst>
              </a:cu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7-29T16:51:42Z</dcterms:created>
  <dc:creator>Verónica Léautaud Sunderland</dc:creator>
  <dc:description/>
  <dc:language>en-US</dc:language>
  <cp:lastModifiedBy> </cp:lastModifiedBy>
  <cp:lastPrinted>2006-06-23T19:18:46Z</cp:lastPrinted>
  <dcterms:modified xsi:type="dcterms:W3CDTF">2007-11-26T16:18:47Z</dcterms:modified>
  <cp:revision>43</cp:revision>
  <dc:subject/>
  <dc:title>PowerPoint Presentation</dc:title>
</cp:coreProperties>
</file>